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906000" cy="6858000" type="A4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71" autoAdjust="0"/>
    <p:restoredTop sz="94660"/>
  </p:normalViewPr>
  <p:slideViewPr>
    <p:cSldViewPr snapToGrid="0" showGuides="1">
      <p:cViewPr varScale="1">
        <p:scale>
          <a:sx n="95" d="100"/>
          <a:sy n="95" d="100"/>
        </p:scale>
        <p:origin x="1344" y="8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50D8D0-1EA8-7646-BD85-F1C3ED78C2B8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900363" y="857250"/>
            <a:ext cx="33432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3FF821-4628-5A4A-91E6-CE9D8D258E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2736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5664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9935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6809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4741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1797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2638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1175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671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6622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7114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0420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B1DD1-98E5-4B55-B549-8B2F59E61F45}" type="datetimeFigureOut">
              <a:rPr lang="en-GB" smtClean="0"/>
              <a:t>30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621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641351" y="5038575"/>
            <a:ext cx="4072468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Figure S5: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acroslide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image of a hepatic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UM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demonstrating how two cores with different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histomorphological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eatures were marked and taken for intra-tumour heterogeneity analysis.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641351" y="1058333"/>
            <a:ext cx="4072468" cy="3564466"/>
            <a:chOff x="4766733" y="1634067"/>
            <a:chExt cx="4072468" cy="3564466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578" t="30846" r="34780" b="5308"/>
            <a:stretch/>
          </p:blipFill>
          <p:spPr>
            <a:xfrm>
              <a:off x="4766733" y="1634067"/>
              <a:ext cx="4072468" cy="3564466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4026" r="92782"/>
            <a:stretch/>
          </p:blipFill>
          <p:spPr>
            <a:xfrm>
              <a:off x="4778479" y="4848081"/>
              <a:ext cx="592134" cy="333518"/>
            </a:xfrm>
            <a:prstGeom prst="rect">
              <a:avLst/>
            </a:prstGeom>
          </p:spPr>
        </p:pic>
        <p:sp>
          <p:nvSpPr>
            <p:cNvPr id="10" name="Oval 9"/>
            <p:cNvSpPr/>
            <p:nvPr/>
          </p:nvSpPr>
          <p:spPr>
            <a:xfrm>
              <a:off x="7137399" y="4106333"/>
              <a:ext cx="270935" cy="258233"/>
            </a:xfrm>
            <a:prstGeom prst="ellipse">
              <a:avLst/>
            </a:prstGeom>
            <a:noFill/>
            <a:ln w="28575">
              <a:solidFill>
                <a:srgbClr val="FFFF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Oval 10"/>
            <p:cNvSpPr/>
            <p:nvPr/>
          </p:nvSpPr>
          <p:spPr>
            <a:xfrm>
              <a:off x="7416801" y="2711449"/>
              <a:ext cx="270935" cy="258233"/>
            </a:xfrm>
            <a:prstGeom prst="ellipse">
              <a:avLst/>
            </a:prstGeom>
            <a:noFill/>
            <a:ln w="28575">
              <a:solidFill>
                <a:srgbClr val="FFFF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36775456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7</TotalTime>
  <Words>26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mini krishna</dc:creator>
  <cp:lastModifiedBy>MDPI japan</cp:lastModifiedBy>
  <cp:revision>39</cp:revision>
  <dcterms:created xsi:type="dcterms:W3CDTF">2020-05-13T06:13:24Z</dcterms:created>
  <dcterms:modified xsi:type="dcterms:W3CDTF">2020-09-30T05:33:49Z</dcterms:modified>
</cp:coreProperties>
</file>